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A8FCC-9641-44C2-BAD0-BD56A6C424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96359-FAE7-4F5D-B639-B402FD954B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5BA45-39AC-4C77-8DC0-C559B7141D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F4C34-890A-493E-A63C-67A53585B4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9FA6F-8477-44CC-A977-E707F9D61F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5F6D4-92E0-49F6-B5C7-F98783A98B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D1B2C-454F-40E2-A5CF-7A43AD150B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3D8B3-096F-4227-A4D3-E2E7C2F0C1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52861-2DC8-43DA-92A1-B5923647EF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4C3B5-B544-46F8-9D25-9E04CD27C3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7131F-20B3-44F0-95B2-B573F485C0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25830-4B36-45D5-85C8-C7E96AA00B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4ABA38-E1F4-498F-BE1E-4279E426C649}" type="slidenum"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51760" y="1415880"/>
            <a:ext cx="51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°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 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043080" y="2055960"/>
            <a:ext cx="32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E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357360" y="1461960"/>
            <a:ext cx="803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PE2/NP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867200" y="1452600"/>
            <a:ext cx="81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PE2/c-my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360960" y="2060640"/>
            <a:ext cx="497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NPM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809880" y="2060640"/>
            <a:ext cx="669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E2/NPM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503600" y="2075040"/>
            <a:ext cx="32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E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820040" y="2070000"/>
            <a:ext cx="497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NPM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229720" y="2070000"/>
            <a:ext cx="685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E2/c-my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172960" y="140976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新細明體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93880" y="2946240"/>
            <a:ext cx="496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994840" y="22622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.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393360" y="22654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7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907440" y="22604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7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456800" y="22622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.0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855320" y="22654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9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331600" y="22604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9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988000" y="247824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7.9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386520" y="248112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2.7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900960" y="247644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2.7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450320" y="247824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8.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848840" y="248112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4.8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324760" y="247644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4.8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988000" y="26938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26.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386520" y="269712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9.9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900960" y="269244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19.9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450320" y="269388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30.9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848840" y="269712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27.0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324760" y="2692440"/>
            <a:ext cx="46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27.0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865080" y="2946240"/>
            <a:ext cx="5133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°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 Ab: FITC (green) for PE2 ; Rodamin (Red) for NPM1 or c-myc; Goat:G; Mouse: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690480" y="2400480"/>
            <a:ext cx="709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EBV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473120" y="2058840"/>
            <a:ext cx="511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Gree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925640" y="2054160"/>
            <a:ext cx="39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R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279160" y="2054160"/>
            <a:ext cx="759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Green/R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519920" y="22622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918440" y="22654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432880" y="22604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524600" y="24782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6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923120" y="2481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427840" y="24764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524600" y="26938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923120" y="269712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427840" y="269244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.3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32560" y="2259000"/>
            <a:ext cx="47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0 d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132560" y="2475000"/>
            <a:ext cx="47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3 d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132560" y="2690640"/>
            <a:ext cx="47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7 da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893880" y="2014560"/>
            <a:ext cx="496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893880" y="1712880"/>
            <a:ext cx="496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200240" y="2287440"/>
            <a:ext cx="0" cy="649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200240" y="2287440"/>
            <a:ext cx="468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-44640" y="15840"/>
            <a:ext cx="112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新細明體"/>
              </a:rPr>
              <a:t>Tabl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840600" y="1749600"/>
            <a:ext cx="51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°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 A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636200" y="1735200"/>
            <a:ext cx="132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G-FITC/M-Roda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895320" y="1389240"/>
            <a:ext cx="496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048840" y="1735200"/>
            <a:ext cx="132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G-FITC/M-Roda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555440" y="1735200"/>
            <a:ext cx="132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G-FITC/M-Roda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702400" y="2490840"/>
            <a:ext cx="29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767560" y="2287440"/>
            <a:ext cx="0" cy="649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3T07:43:06Z</dcterms:created>
  <dc:creator>User</dc:creator>
  <dc:description/>
  <dc:language>en-US</dc:language>
  <cp:lastModifiedBy>MC SYSTEM</cp:lastModifiedBy>
  <dcterms:modified xsi:type="dcterms:W3CDTF">2012-09-11T04:27:32Z</dcterms:modified>
  <cp:revision>1642</cp:revision>
  <dc:subject/>
  <dc:title>投影片 1</dc:title>
</cp:coreProperties>
</file>